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925" r:id="rId2"/>
  </p:sldIdLst>
  <p:sldSz cx="64008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07" d="100"/>
          <a:sy n="107" d="100"/>
        </p:scale>
        <p:origin x="323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197FFD-F7D0-6B44-8E50-F054F3374A90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28850" y="1143000"/>
            <a:ext cx="2400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E3D2CB-36E4-CC4C-8389-D626B50AD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6055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62050"/>
            <a:ext cx="2438400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endParaRPr lang="en-US" b="0" i="0" u="none" strike="noStrike" dirty="0">
              <a:solidFill>
                <a:srgbClr val="222222"/>
              </a:solidFill>
              <a:effectLst/>
              <a:latin typeface="-apple-system"/>
            </a:endParaRPr>
          </a:p>
          <a:p>
            <a:pPr defTabSz="931774"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E0831B8-45F1-A34F-843C-4C3E578001B9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71372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619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244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030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450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065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424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519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591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865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333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270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359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4D7269D-D379-47D3-989D-B6945AF67056}"/>
              </a:ext>
            </a:extLst>
          </p:cNvPr>
          <p:cNvSpPr txBox="1"/>
          <p:nvPr/>
        </p:nvSpPr>
        <p:spPr>
          <a:xfrm>
            <a:off x="379258" y="3653741"/>
            <a:ext cx="5534653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 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ibial Plateaus from four 65-74 yr. old male subjects 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clinically diagnosed stage IV osteoarthritis (O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ceiving total knee replacement were recruited 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ough referral from orthopedic surgeons at a Department of Veterans Affairs Medical Center, San Francisco. Fresh control cadaveric tissues (n=4) were obtained through the Willed Body Program at University of California, San Francisco  from age, sex, and BMI matched donors without history of OA, osteonecrosis, osteoporosis, or fractures. * p &lt; 0.05 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y student’s T-Test showing that the control and OA patient cohorts can be distinguished by the OARSI grade (A) but are both BMI (B) and age (C) matched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8A79869-5676-4057-8783-4E292C5E57E5}"/>
              </a:ext>
            </a:extLst>
          </p:cNvPr>
          <p:cNvSpPr txBox="1"/>
          <p:nvPr/>
        </p:nvSpPr>
        <p:spPr>
          <a:xfrm>
            <a:off x="438637" y="124557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28F06F2-6E2C-4F26-BD94-A7973C973C6B}"/>
              </a:ext>
            </a:extLst>
          </p:cNvPr>
          <p:cNvSpPr txBox="1"/>
          <p:nvPr/>
        </p:nvSpPr>
        <p:spPr>
          <a:xfrm>
            <a:off x="2151124" y="124557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57DDB25-A26E-4EF7-AC63-58FCF2130F0D}"/>
              </a:ext>
            </a:extLst>
          </p:cNvPr>
          <p:cNvSpPr txBox="1"/>
          <p:nvPr/>
        </p:nvSpPr>
        <p:spPr>
          <a:xfrm>
            <a:off x="3883972" y="124557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8951C6E-E186-7A51-CC35-19AFF5028D7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882" r="28353"/>
          <a:stretch/>
        </p:blipFill>
        <p:spPr>
          <a:xfrm>
            <a:off x="904777" y="1249456"/>
            <a:ext cx="1615569" cy="226693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FF77426-DF04-88C4-D00A-3A72A6E1486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1640"/>
          <a:stretch/>
        </p:blipFill>
        <p:spPr>
          <a:xfrm>
            <a:off x="4121478" y="1246776"/>
            <a:ext cx="1864563" cy="227596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88E1117B-62BE-A63C-42C3-62293312AFD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38689"/>
          <a:stretch/>
        </p:blipFill>
        <p:spPr>
          <a:xfrm>
            <a:off x="2374330" y="1167423"/>
            <a:ext cx="1615569" cy="235622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8663038-6242-E9DD-DD91-11F8BE870B34}"/>
              </a:ext>
            </a:extLst>
          </p:cNvPr>
          <p:cNvSpPr txBox="1"/>
          <p:nvPr/>
        </p:nvSpPr>
        <p:spPr>
          <a:xfrm rot="16200000">
            <a:off x="212065" y="2232549"/>
            <a:ext cx="11416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ARSI Score</a:t>
            </a:r>
          </a:p>
        </p:txBody>
      </p:sp>
    </p:spTree>
    <p:extLst>
      <p:ext uri="{BB962C8B-B14F-4D97-AF65-F5344CB8AC3E}">
        <p14:creationId xmlns:p14="http://schemas.microsoft.com/office/powerpoint/2010/main" val="3394876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</TotalTime>
  <Words>136</Words>
  <Application>Microsoft Macintosh PowerPoint</Application>
  <PresentationFormat>Custom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-apple-system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ie Schurman</dc:creator>
  <cp:lastModifiedBy>Charlie Schurman</cp:lastModifiedBy>
  <cp:revision>7</cp:revision>
  <dcterms:created xsi:type="dcterms:W3CDTF">2024-02-20T19:43:53Z</dcterms:created>
  <dcterms:modified xsi:type="dcterms:W3CDTF">2024-06-18T21:07:53Z</dcterms:modified>
</cp:coreProperties>
</file>